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4C609-C57E-4C51-A111-CEF27CE129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A724A-1F36-4825-99AA-9DCA5FC1BB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035AE3-FAEB-403A-9D8E-A35FE447E7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B2CE3D-E773-432F-8A61-57C575A453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C6DBD2-DC24-4F1A-848B-A1AEB010AB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4AB75-116B-432E-90D2-AA78D62E1F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206C69-256B-4C79-813D-50E5D9A19D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8508E2-32FF-411B-BC87-0E280D9F43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79A9E-D3FD-46FC-80A9-9A2BF2A59D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3EFD65-9444-41F2-94AB-AE7387B824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889F7-44C6-495D-A22E-084806FD87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31C1F6-9A7B-4996-A222-A1F606FD9D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0BBC45-3CEF-4028-A493-89DB049D5A39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28760" y="1000080"/>
          <a:ext cx="8208720" cy="5418360"/>
        </p:xfrm>
        <a:graphic>
          <a:graphicData uri="http://schemas.openxmlformats.org/drawingml/2006/table">
            <a:tbl>
              <a:tblPr/>
              <a:tblGrid>
                <a:gridCol w="2646360"/>
                <a:gridCol w="388800"/>
                <a:gridCol w="243000"/>
                <a:gridCol w="280800"/>
                <a:gridCol w="279360"/>
                <a:gridCol w="279360"/>
                <a:gridCol w="243000"/>
                <a:gridCol w="279360"/>
                <a:gridCol w="279360"/>
                <a:gridCol w="281160"/>
                <a:gridCol w="243000"/>
                <a:gridCol w="279360"/>
                <a:gridCol w="279360"/>
                <a:gridCol w="279360"/>
                <a:gridCol w="243000"/>
                <a:gridCol w="280800"/>
                <a:gridCol w="277920"/>
                <a:gridCol w="280800"/>
                <a:gridCol w="279360"/>
                <a:gridCol w="565200"/>
              </a:tblGrid>
              <a:tr h="257400"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Gene Nam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Symbo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H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H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H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H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H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H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H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H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M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M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M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M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M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M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M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M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/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7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Accession no.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a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6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8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7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08301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a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8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08300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a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6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2310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a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5.8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7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7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7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8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3116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a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31165.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a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3116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a9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0481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12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a12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7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3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8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5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5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8306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80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b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8.3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0.7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0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3.3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4.8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9.4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19.7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3560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b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4441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b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8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8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4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7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7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9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30704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90kDa alpha (cytosolic), class A member 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c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6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5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5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9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7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048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90kDa alpha (cytosolic), class B member 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c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08302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90kDa alpha (cytosolic), class B member 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c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7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7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08302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90kDa alpha (cytosolic), class B member 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c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9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6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7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8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8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08302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90kDa beta (Grp94), member 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90b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1631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1 (chaperonin 10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e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5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5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9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9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8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08303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1 (chaperonin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d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0477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1 (chaperonin)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d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4.5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5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5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7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0477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eat shock protein 1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Hsp10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2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8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7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4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4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3559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A, member 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a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0829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A, member 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a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9794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A, member 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a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3646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A, member 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a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2.8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53.6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7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16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5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9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4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1422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76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B, member 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b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5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5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4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8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5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5.8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9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8808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B, member 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b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9874.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B, member 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b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1847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B, member 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b1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6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9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78055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B, member 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b1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9965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related, subfamily B, member 1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b1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53527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7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8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7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0958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0566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6775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5 beta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5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5489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19795.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72400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1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1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72704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1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1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9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72704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1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1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XM_135146.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1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1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8873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76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1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16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6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5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7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72338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1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17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139139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 (Hsp40) homolog, subfamily C, member 1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Dnajc18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9669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rystallin, alpha 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ryab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6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12.7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9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5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4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7.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14.4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11.3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0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4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3.3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5.3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09964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0944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rystallin, beta A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ryba4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8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3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6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3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6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5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1351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09800"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rystallin, beta B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rybb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2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8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9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5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8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돋움"/>
                        </a:rPr>
                        <a:t>2.2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180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3695.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27080"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rystallin, beta B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rybb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2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7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1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5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4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16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0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1.01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-1.03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M_021352.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 Box 4170"/>
          <p:cNvSpPr/>
          <p:nvPr/>
        </p:nvSpPr>
        <p:spPr>
          <a:xfrm>
            <a:off x="104040" y="0"/>
            <a:ext cx="2504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Supplemental Table 6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Text Box 4"/>
          <p:cNvSpPr/>
          <p:nvPr/>
        </p:nvSpPr>
        <p:spPr>
          <a:xfrm>
            <a:off x="642960" y="428760"/>
            <a:ext cx="7653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able S6. Heat shock protein family members are listed with their mRNA levels in response to heat shock and MG132 treatment. Fold changes more than 2 are colored in red and less than -2 are colored in green.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3T02:49:26Z</dcterms:created>
  <dc:creator>김희정</dc:creator>
  <dc:description/>
  <dc:language>en-US</dc:language>
  <cp:lastModifiedBy>김희정</cp:lastModifiedBy>
  <dcterms:modified xsi:type="dcterms:W3CDTF">2011-06-14T01:52:54Z</dcterms:modified>
  <cp:revision>199</cp:revision>
  <dc:subject/>
  <dc:title>슬라이드 1</dc:title>
</cp:coreProperties>
</file>